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370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3" autoAdjust="0"/>
    <p:restoredTop sz="81148" autoAdjust="0"/>
  </p:normalViewPr>
  <p:slideViewPr>
    <p:cSldViewPr snapToGrid="0">
      <p:cViewPr varScale="1">
        <p:scale>
          <a:sx n="63" d="100"/>
          <a:sy n="63" d="100"/>
        </p:scale>
        <p:origin x="1253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FEE4C8-6B8C-4E7E-97A0-38619CB658B5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563745-6BFF-404B-B120-70FFD69101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3765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048FE1-5E98-B2FB-ECBE-89AF1935F6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1FCDFE16-A214-9876-769B-362E354E227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A50EEC8D-AE76-5EB1-CD88-616B07D365B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b="1" dirty="0"/>
              <a:t>Figure S2. Cytotoxicity of the crude </a:t>
            </a:r>
            <a:r>
              <a:rPr lang="en-US" altLang="ko-KR" b="1" i="1" dirty="0" err="1"/>
              <a:t>Phellodendron</a:t>
            </a:r>
            <a:r>
              <a:rPr lang="en-US" altLang="ko-KR" b="1" i="1" dirty="0"/>
              <a:t> </a:t>
            </a:r>
            <a:r>
              <a:rPr lang="en-US" altLang="ko-KR" b="1" i="1" dirty="0" err="1"/>
              <a:t>amurense</a:t>
            </a:r>
            <a:r>
              <a:rPr lang="en-US" altLang="ko-KR" b="1" dirty="0"/>
              <a:t> leaf extract (PL extract) and its n-hexane fraction in EPC cells. </a:t>
            </a:r>
            <a:r>
              <a:rPr lang="en-US" altLang="ko-KR" dirty="0"/>
              <a:t>(A) Cell viability of EPC cells treated with the crude PL extract. (B) Cell viability of EPC cells treated with the n-hexane fraction. Cell viability (%) was calculated as (</a:t>
            </a:r>
            <a:r>
              <a:rPr lang="en-US" altLang="ko-KR" dirty="0" err="1"/>
              <a:t>A</a:t>
            </a:r>
            <a:r>
              <a:rPr lang="en-US" altLang="ko-KR" baseline="-25000" dirty="0" err="1"/>
              <a:t>sample</a:t>
            </a:r>
            <a:r>
              <a:rPr lang="en-US" altLang="ko-KR" dirty="0"/>
              <a:t> − </a:t>
            </a:r>
            <a:r>
              <a:rPr lang="en-US" altLang="ko-KR" dirty="0" err="1"/>
              <a:t>A</a:t>
            </a:r>
            <a:r>
              <a:rPr lang="en-US" altLang="ko-KR" baseline="-25000" dirty="0" err="1"/>
              <a:t>blank</a:t>
            </a:r>
            <a:r>
              <a:rPr lang="en-US" altLang="ko-KR" dirty="0"/>
              <a:t>)/(</a:t>
            </a:r>
            <a:r>
              <a:rPr lang="en-US" altLang="ko-KR" dirty="0" err="1"/>
              <a:t>A</a:t>
            </a:r>
            <a:r>
              <a:rPr lang="en-US" altLang="ko-KR" baseline="-25000" dirty="0" err="1"/>
              <a:t>control</a:t>
            </a:r>
            <a:r>
              <a:rPr lang="en-US" altLang="ko-KR" dirty="0"/>
              <a:t> − </a:t>
            </a:r>
            <a:r>
              <a:rPr lang="en-US" altLang="ko-KR" dirty="0" err="1"/>
              <a:t>A</a:t>
            </a:r>
            <a:r>
              <a:rPr lang="en-US" altLang="ko-KR" baseline="-25000" dirty="0" err="1"/>
              <a:t>blank</a:t>
            </a:r>
            <a:r>
              <a:rPr lang="en-US" altLang="ko-KR" dirty="0"/>
              <a:t>) × 100. Data are presented as the mean ± SEM of three independent experiments</a:t>
            </a:r>
          </a:p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A0BBA84-9031-729A-4DF8-C3489DE4243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ED6D6A-EB84-46F3-8F8C-483BD340FF21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17735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2D08A43-E791-081E-7E68-2B8C43D484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6432EBBF-EECF-0648-94BC-74183DC390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07E7AF9-F76C-B1B5-1AE7-FEE3B0C98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52A68ED-463F-8522-223A-500BFEA69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4E0C9E8-234A-B030-25CE-481A91EF0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3153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F7CB121-CF7D-B458-A49A-1AF5115AEC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AE66016-C586-A5C3-E7D3-A9DB38D01D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BDC1F41-E8AE-1AF7-C373-6A6E50880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77ACA91-2A4D-5117-99AF-FD4592236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180035C-7836-1FC2-84B5-5224D82D1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2616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3A1429E-B455-7C79-6F25-F9454C215D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0AF652B-9401-07FE-E349-307ADC544D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B7F83BE-5026-FF3B-CAB6-582C4824B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C3AD473-C4CD-68A8-5703-10A467A92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4502398-449D-E344-7A88-85F3B135A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9499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4C488C-569C-4876-8935-98F3810AAE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6874B1A-8B95-ED64-0890-FA08066329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E7D8907-7E68-846D-9753-D69C251E8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C83F720-569B-05EE-8AA2-A6EEA7B26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4CD1315-D126-D8F0-4FE2-49887190C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4496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936D42E-24CB-00B2-1CF5-2223B8C850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D291DEC-4A3D-9497-C505-9F67FA2AA5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21CD3AC-B40D-A18A-04CA-0F961AF15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5D565DD-7500-BA70-5657-23AC4B945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F89C075-AB90-2458-4231-00CEF2FF50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4742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FE67FE7-7464-2398-4D66-9D9573478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80CC04F-8D5A-4B6E-1436-F6BFFE2560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480D0DF-F6AC-64C7-EEBB-9D3A485C60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1CF1838-E4D7-E6E2-A489-545E3CBE3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AA39003-53F6-7D07-3720-72BEB447E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44C4C76-6A14-ECFA-A53E-A8808A568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3887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4E21368-0A81-D0CA-E5D6-6B5DBDCDA5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0E9A631-3964-688D-F636-A4F28A144F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D53CAA7-1735-0B72-4888-C83A23AC5F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7B0DBF0-E3D7-FE18-AC78-CCA8CC4604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0A11568A-E44A-8F07-A1CF-13D1FD567F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6A32B8A7-6D45-193B-D448-FAE57B597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7673375-12DB-582A-BAFE-97F0C6021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0496AC74-45E4-2BFD-3C50-FCBEE6695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632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C519BA0-0C19-7B33-E03A-BD711E79C3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3918FCE-6F77-115B-0EF1-E81973AB5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8E62A35-3FA7-6386-B537-F11FFBA4F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57393AB-0F27-A7D3-A1B3-9BCEE81BF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5542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CEBFEA5D-532E-7B56-DE84-54780536B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C64F2463-2371-A7D7-2FBA-C200D27B6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60E4200E-2292-5E91-74DE-8B6C8B64C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3220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55C1639-91E8-DD9C-1048-C3904B3E7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75A14FA-A564-D0D0-F0D7-F54D515FA6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6A98485-8736-5ACD-2FD0-3F4B54C341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63684AA-4281-3A71-D1FE-12778A0C7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6E06244-75FB-459F-31F2-9B857ABF3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7550FEA-0F23-121E-88B0-AE9DD0DE1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5218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67EABFE-B98C-6ACA-AE5F-2DF8136186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708C266E-1BEA-B7D8-12F7-F25C5BF0EF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E143E34-D162-A9E4-9C17-FF064FC009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8F73F8A-AB06-FAC0-EDA2-79782DE85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89094C4-C68D-E20D-AB06-32A4DB534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4CA9F18-64EF-096F-7EDE-EFEF45B6F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5259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91D26D6-10F2-6280-7037-DDDC80F6A5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197FF50-9E13-5D25-D4CE-ED614D61C0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F7432D8-744A-A148-0889-E2314DD9D4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C2AF9E-77FA-4051-BA43-1D73FC7DBF76}" type="datetimeFigureOut">
              <a:rPr lang="ko-KR" altLang="en-US" smtClean="0"/>
              <a:t>2026-03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7BD358C-0A87-E565-09F0-2EA057336D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E7CF3D5-41E0-602B-8A0C-54F6721030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11451D-D6E8-409E-9224-13BF6096C8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8839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3B5598F4-FD87-9306-1BE1-C7433B6030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0914" y="1243686"/>
            <a:ext cx="5409139" cy="380799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69E771D-8D25-6EC6-CCE5-E4AD2C68C799}"/>
              </a:ext>
            </a:extLst>
          </p:cNvPr>
          <p:cNvSpPr txBox="1"/>
          <p:nvPr/>
        </p:nvSpPr>
        <p:spPr>
          <a:xfrm>
            <a:off x="2308485" y="5261548"/>
            <a:ext cx="748758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Figure S1. Antiviral activity of the crude </a:t>
            </a:r>
            <a:r>
              <a:rPr lang="en-US" altLang="ko-KR" sz="1200" b="1" i="1" dirty="0" err="1"/>
              <a:t>Phellodendron</a:t>
            </a:r>
            <a:r>
              <a:rPr lang="en-US" altLang="ko-KR" sz="1200" b="1" i="1" dirty="0"/>
              <a:t> </a:t>
            </a:r>
            <a:r>
              <a:rPr lang="en-US" altLang="ko-KR" sz="1200" b="1" i="1" dirty="0" err="1"/>
              <a:t>amurense</a:t>
            </a:r>
            <a:r>
              <a:rPr lang="en-US" altLang="ko-KR" sz="1200" b="1" dirty="0"/>
              <a:t> leaf extract (PL extract) used for solvent fractionation against </a:t>
            </a:r>
            <a:r>
              <a:rPr lang="en-US" altLang="ko-KR" sz="1200" b="1" dirty="0" err="1"/>
              <a:t>rVHSV</a:t>
            </a:r>
            <a:r>
              <a:rPr lang="en-US" altLang="ko-KR" sz="1200" b="1" dirty="0"/>
              <a:t>. </a:t>
            </a:r>
            <a:r>
              <a:rPr lang="en-US" altLang="ko-KR" sz="1200" dirty="0"/>
              <a:t>Inhibition of </a:t>
            </a:r>
            <a:r>
              <a:rPr lang="en-US" altLang="ko-KR" sz="1200" dirty="0" err="1"/>
              <a:t>rVHSV</a:t>
            </a:r>
            <a:r>
              <a:rPr lang="en-US" altLang="ko-KR" sz="1200" dirty="0"/>
              <a:t> infectivity by the crude PL extract was determined by plaque assay. Viral infectivity (%) was calculated as the percentage of plaque-forming units (PFU) in treated samples relative to the virus-infected control. Data are presented as the mean ± SEM of three independent experiments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22862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43B3408-EEB6-A2BB-0A37-CF2956CFC1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E278D9D-B0F7-3EE3-C02F-7758CD81A25C}"/>
              </a:ext>
            </a:extLst>
          </p:cNvPr>
          <p:cNvSpPr txBox="1"/>
          <p:nvPr/>
        </p:nvSpPr>
        <p:spPr>
          <a:xfrm>
            <a:off x="110492" y="395861"/>
            <a:ext cx="594046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4522653-6D98-86F9-C51D-59CEDDBF1413}"/>
              </a:ext>
            </a:extLst>
          </p:cNvPr>
          <p:cNvSpPr txBox="1"/>
          <p:nvPr/>
        </p:nvSpPr>
        <p:spPr>
          <a:xfrm>
            <a:off x="6034370" y="441918"/>
            <a:ext cx="442449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D8269463-0B01-AD66-7B7A-9B90D9BA4CE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256" y="1149707"/>
            <a:ext cx="5494151" cy="5149888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CFD32B8C-D296-F1FE-EA5F-ADA124F3AB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3441" y="1041816"/>
            <a:ext cx="5861156" cy="52577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7976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3</Words>
  <Application>Microsoft Office PowerPoint</Application>
  <PresentationFormat>와이드스크린</PresentationFormat>
  <Paragraphs>5</Paragraphs>
  <Slides>2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수연 김</dc:creator>
  <cp:lastModifiedBy>User</cp:lastModifiedBy>
  <cp:revision>3</cp:revision>
  <dcterms:created xsi:type="dcterms:W3CDTF">2026-03-24T02:30:45Z</dcterms:created>
  <dcterms:modified xsi:type="dcterms:W3CDTF">2026-03-30T00:06:17Z</dcterms:modified>
</cp:coreProperties>
</file>